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notesMasterIdLst>
    <p:notesMasterId r:id="rId3"/>
  </p:notesMasterIdLst>
  <p:sldIdLst>
    <p:sldId id="256" r:id="rId2"/>
  </p:sldIdLst>
  <p:sldSz cx="50399950" cy="5039995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Untitled Section" id="{EB099AA0-69EB-49DD-9A2C-205D725BB64D}">
          <p14:sldIdLst>
            <p14:sldId id="25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24" autoAdjust="0"/>
    <p:restoredTop sz="86449" autoAdjust="0"/>
  </p:normalViewPr>
  <p:slideViewPr>
    <p:cSldViewPr snapToGrid="0">
      <p:cViewPr>
        <p:scale>
          <a:sx n="10" d="100"/>
          <a:sy n="10" d="100"/>
        </p:scale>
        <p:origin x="2611" y="8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83E636-1054-43F3-AEB0-A2F959FF8FE0}" type="datetimeFigureOut">
              <a:rPr lang="en-GB" smtClean="0"/>
              <a:t>09/1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14713" y="857250"/>
            <a:ext cx="23145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6DCAAB-1647-4DCF-9FE8-3C9502DC9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23286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92230" rtl="0" eaLnBrk="1" latinLnBrk="0" hangingPunct="1">
      <a:defRPr sz="1696" kern="1200">
        <a:solidFill>
          <a:schemeClr val="tx1"/>
        </a:solidFill>
        <a:latin typeface="+mn-lt"/>
        <a:ea typeface="+mn-ea"/>
        <a:cs typeface="+mn-cs"/>
      </a:defRPr>
    </a:lvl1pPr>
    <a:lvl2pPr marL="646115" algn="l" defTabSz="1292230" rtl="0" eaLnBrk="1" latinLnBrk="0" hangingPunct="1">
      <a:defRPr sz="1696" kern="1200">
        <a:solidFill>
          <a:schemeClr val="tx1"/>
        </a:solidFill>
        <a:latin typeface="+mn-lt"/>
        <a:ea typeface="+mn-ea"/>
        <a:cs typeface="+mn-cs"/>
      </a:defRPr>
    </a:lvl2pPr>
    <a:lvl3pPr marL="1292230" algn="l" defTabSz="1292230" rtl="0" eaLnBrk="1" latinLnBrk="0" hangingPunct="1">
      <a:defRPr sz="1696" kern="1200">
        <a:solidFill>
          <a:schemeClr val="tx1"/>
        </a:solidFill>
        <a:latin typeface="+mn-lt"/>
        <a:ea typeface="+mn-ea"/>
        <a:cs typeface="+mn-cs"/>
      </a:defRPr>
    </a:lvl3pPr>
    <a:lvl4pPr marL="1938345" algn="l" defTabSz="1292230" rtl="0" eaLnBrk="1" latinLnBrk="0" hangingPunct="1">
      <a:defRPr sz="1696" kern="1200">
        <a:solidFill>
          <a:schemeClr val="tx1"/>
        </a:solidFill>
        <a:latin typeface="+mn-lt"/>
        <a:ea typeface="+mn-ea"/>
        <a:cs typeface="+mn-cs"/>
      </a:defRPr>
    </a:lvl4pPr>
    <a:lvl5pPr marL="2584460" algn="l" defTabSz="1292230" rtl="0" eaLnBrk="1" latinLnBrk="0" hangingPunct="1">
      <a:defRPr sz="1696" kern="1200">
        <a:solidFill>
          <a:schemeClr val="tx1"/>
        </a:solidFill>
        <a:latin typeface="+mn-lt"/>
        <a:ea typeface="+mn-ea"/>
        <a:cs typeface="+mn-cs"/>
      </a:defRPr>
    </a:lvl5pPr>
    <a:lvl6pPr marL="3230575" algn="l" defTabSz="1292230" rtl="0" eaLnBrk="1" latinLnBrk="0" hangingPunct="1">
      <a:defRPr sz="1696" kern="1200">
        <a:solidFill>
          <a:schemeClr val="tx1"/>
        </a:solidFill>
        <a:latin typeface="+mn-lt"/>
        <a:ea typeface="+mn-ea"/>
        <a:cs typeface="+mn-cs"/>
      </a:defRPr>
    </a:lvl6pPr>
    <a:lvl7pPr marL="3876690" algn="l" defTabSz="1292230" rtl="0" eaLnBrk="1" latinLnBrk="0" hangingPunct="1">
      <a:defRPr sz="1696" kern="1200">
        <a:solidFill>
          <a:schemeClr val="tx1"/>
        </a:solidFill>
        <a:latin typeface="+mn-lt"/>
        <a:ea typeface="+mn-ea"/>
        <a:cs typeface="+mn-cs"/>
      </a:defRPr>
    </a:lvl7pPr>
    <a:lvl8pPr marL="4522805" algn="l" defTabSz="1292230" rtl="0" eaLnBrk="1" latinLnBrk="0" hangingPunct="1">
      <a:defRPr sz="1696" kern="1200">
        <a:solidFill>
          <a:schemeClr val="tx1"/>
        </a:solidFill>
        <a:latin typeface="+mn-lt"/>
        <a:ea typeface="+mn-ea"/>
        <a:cs typeface="+mn-cs"/>
      </a:defRPr>
    </a:lvl8pPr>
    <a:lvl9pPr marL="5168920" algn="l" defTabSz="1292230" rtl="0" eaLnBrk="1" latinLnBrk="0" hangingPunct="1">
      <a:defRPr sz="169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414713" y="857250"/>
            <a:ext cx="2314575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6DCAAB-1647-4DCF-9FE8-3C9502DC9EA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81424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779996" y="8248329"/>
            <a:ext cx="42839958" cy="17546649"/>
          </a:xfrm>
        </p:spPr>
        <p:txBody>
          <a:bodyPr anchor="b"/>
          <a:lstStyle>
            <a:lvl1pPr algn="ctr">
              <a:defRPr sz="3307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299994" y="26471644"/>
            <a:ext cx="37799963" cy="12168318"/>
          </a:xfrm>
        </p:spPr>
        <p:txBody>
          <a:bodyPr/>
          <a:lstStyle>
            <a:lvl1pPr marL="0" indent="0" algn="ctr">
              <a:buNone/>
              <a:defRPr sz="13228"/>
            </a:lvl1pPr>
            <a:lvl2pPr marL="2519995" indent="0" algn="ctr">
              <a:buNone/>
              <a:defRPr sz="11024"/>
            </a:lvl2pPr>
            <a:lvl3pPr marL="5039990" indent="0" algn="ctr">
              <a:buNone/>
              <a:defRPr sz="9921"/>
            </a:lvl3pPr>
            <a:lvl4pPr marL="7559985" indent="0" algn="ctr">
              <a:buNone/>
              <a:defRPr sz="8819"/>
            </a:lvl4pPr>
            <a:lvl5pPr marL="10079980" indent="0" algn="ctr">
              <a:buNone/>
              <a:defRPr sz="8819"/>
            </a:lvl5pPr>
            <a:lvl6pPr marL="12599975" indent="0" algn="ctr">
              <a:buNone/>
              <a:defRPr sz="8819"/>
            </a:lvl6pPr>
            <a:lvl7pPr marL="15119970" indent="0" algn="ctr">
              <a:buNone/>
              <a:defRPr sz="8819"/>
            </a:lvl7pPr>
            <a:lvl8pPr marL="17639965" indent="0" algn="ctr">
              <a:buNone/>
              <a:defRPr sz="8819"/>
            </a:lvl8pPr>
            <a:lvl9pPr marL="20159960" indent="0" algn="ctr">
              <a:buNone/>
              <a:defRPr sz="8819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123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769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6067467" y="2683331"/>
            <a:ext cx="10867489" cy="427116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64999" y="2683331"/>
            <a:ext cx="31972468" cy="4271162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077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917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38749" y="12565002"/>
            <a:ext cx="43469957" cy="20964976"/>
          </a:xfrm>
        </p:spPr>
        <p:txBody>
          <a:bodyPr anchor="b"/>
          <a:lstStyle>
            <a:lvl1pPr>
              <a:defRPr sz="3307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38749" y="33728315"/>
            <a:ext cx="43469957" cy="11024985"/>
          </a:xfrm>
        </p:spPr>
        <p:txBody>
          <a:bodyPr/>
          <a:lstStyle>
            <a:lvl1pPr marL="0" indent="0">
              <a:buNone/>
              <a:defRPr sz="13228">
                <a:solidFill>
                  <a:schemeClr val="tx1"/>
                </a:solidFill>
              </a:defRPr>
            </a:lvl1pPr>
            <a:lvl2pPr marL="2519995" indent="0">
              <a:buNone/>
              <a:defRPr sz="11024">
                <a:solidFill>
                  <a:schemeClr val="tx1">
                    <a:tint val="75000"/>
                  </a:schemeClr>
                </a:solidFill>
              </a:defRPr>
            </a:lvl2pPr>
            <a:lvl3pPr marL="5039990" indent="0">
              <a:buNone/>
              <a:defRPr sz="9921">
                <a:solidFill>
                  <a:schemeClr val="tx1">
                    <a:tint val="75000"/>
                  </a:schemeClr>
                </a:solidFill>
              </a:defRPr>
            </a:lvl3pPr>
            <a:lvl4pPr marL="7559985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4pPr>
            <a:lvl5pPr marL="10079980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5pPr>
            <a:lvl6pPr marL="12599975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6pPr>
            <a:lvl7pPr marL="15119970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7pPr>
            <a:lvl8pPr marL="17639965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8pPr>
            <a:lvl9pPr marL="20159960" indent="0">
              <a:buNone/>
              <a:defRPr sz="88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693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64996" y="13416653"/>
            <a:ext cx="21419979" cy="3197830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514975" y="13416653"/>
            <a:ext cx="21419979" cy="3197830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62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561" y="2683342"/>
            <a:ext cx="43469957" cy="974166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71567" y="12354992"/>
            <a:ext cx="21321538" cy="6054990"/>
          </a:xfrm>
        </p:spPr>
        <p:txBody>
          <a:bodyPr anchor="b"/>
          <a:lstStyle>
            <a:lvl1pPr marL="0" indent="0">
              <a:buNone/>
              <a:defRPr sz="13228" b="1"/>
            </a:lvl1pPr>
            <a:lvl2pPr marL="2519995" indent="0">
              <a:buNone/>
              <a:defRPr sz="11024" b="1"/>
            </a:lvl2pPr>
            <a:lvl3pPr marL="5039990" indent="0">
              <a:buNone/>
              <a:defRPr sz="9921" b="1"/>
            </a:lvl3pPr>
            <a:lvl4pPr marL="7559985" indent="0">
              <a:buNone/>
              <a:defRPr sz="8819" b="1"/>
            </a:lvl4pPr>
            <a:lvl5pPr marL="10079980" indent="0">
              <a:buNone/>
              <a:defRPr sz="8819" b="1"/>
            </a:lvl5pPr>
            <a:lvl6pPr marL="12599975" indent="0">
              <a:buNone/>
              <a:defRPr sz="8819" b="1"/>
            </a:lvl6pPr>
            <a:lvl7pPr marL="15119970" indent="0">
              <a:buNone/>
              <a:defRPr sz="8819" b="1"/>
            </a:lvl7pPr>
            <a:lvl8pPr marL="17639965" indent="0">
              <a:buNone/>
              <a:defRPr sz="8819" b="1"/>
            </a:lvl8pPr>
            <a:lvl9pPr marL="20159960" indent="0">
              <a:buNone/>
              <a:defRPr sz="8819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567" y="18409982"/>
            <a:ext cx="21321538" cy="2707831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5514978" y="12354992"/>
            <a:ext cx="21426543" cy="6054990"/>
          </a:xfrm>
        </p:spPr>
        <p:txBody>
          <a:bodyPr anchor="b"/>
          <a:lstStyle>
            <a:lvl1pPr marL="0" indent="0">
              <a:buNone/>
              <a:defRPr sz="13228" b="1"/>
            </a:lvl1pPr>
            <a:lvl2pPr marL="2519995" indent="0">
              <a:buNone/>
              <a:defRPr sz="11024" b="1"/>
            </a:lvl2pPr>
            <a:lvl3pPr marL="5039990" indent="0">
              <a:buNone/>
              <a:defRPr sz="9921" b="1"/>
            </a:lvl3pPr>
            <a:lvl4pPr marL="7559985" indent="0">
              <a:buNone/>
              <a:defRPr sz="8819" b="1"/>
            </a:lvl4pPr>
            <a:lvl5pPr marL="10079980" indent="0">
              <a:buNone/>
              <a:defRPr sz="8819" b="1"/>
            </a:lvl5pPr>
            <a:lvl6pPr marL="12599975" indent="0">
              <a:buNone/>
              <a:defRPr sz="8819" b="1"/>
            </a:lvl6pPr>
            <a:lvl7pPr marL="15119970" indent="0">
              <a:buNone/>
              <a:defRPr sz="8819" b="1"/>
            </a:lvl7pPr>
            <a:lvl8pPr marL="17639965" indent="0">
              <a:buNone/>
              <a:defRPr sz="8819" b="1"/>
            </a:lvl8pPr>
            <a:lvl9pPr marL="20159960" indent="0">
              <a:buNone/>
              <a:defRPr sz="8819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5514978" y="18409982"/>
            <a:ext cx="21426543" cy="2707831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054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730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212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561" y="3359997"/>
            <a:ext cx="16255296" cy="11759988"/>
          </a:xfrm>
        </p:spPr>
        <p:txBody>
          <a:bodyPr anchor="b"/>
          <a:lstStyle>
            <a:lvl1pPr>
              <a:defRPr sz="1763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26543" y="7256671"/>
            <a:ext cx="25514975" cy="35816631"/>
          </a:xfrm>
        </p:spPr>
        <p:txBody>
          <a:bodyPr/>
          <a:lstStyle>
            <a:lvl1pPr>
              <a:defRPr sz="17638"/>
            </a:lvl1pPr>
            <a:lvl2pPr>
              <a:defRPr sz="15433"/>
            </a:lvl2pPr>
            <a:lvl3pPr>
              <a:defRPr sz="13228"/>
            </a:lvl3pPr>
            <a:lvl4pPr>
              <a:defRPr sz="11024"/>
            </a:lvl4pPr>
            <a:lvl5pPr>
              <a:defRPr sz="11024"/>
            </a:lvl5pPr>
            <a:lvl6pPr>
              <a:defRPr sz="11024"/>
            </a:lvl6pPr>
            <a:lvl7pPr>
              <a:defRPr sz="11024"/>
            </a:lvl7pPr>
            <a:lvl8pPr>
              <a:defRPr sz="11024"/>
            </a:lvl8pPr>
            <a:lvl9pPr>
              <a:defRPr sz="11024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561" y="15119985"/>
            <a:ext cx="16255296" cy="28011643"/>
          </a:xfrm>
        </p:spPr>
        <p:txBody>
          <a:bodyPr/>
          <a:lstStyle>
            <a:lvl1pPr marL="0" indent="0">
              <a:buNone/>
              <a:defRPr sz="8819"/>
            </a:lvl1pPr>
            <a:lvl2pPr marL="2519995" indent="0">
              <a:buNone/>
              <a:defRPr sz="7717"/>
            </a:lvl2pPr>
            <a:lvl3pPr marL="5039990" indent="0">
              <a:buNone/>
              <a:defRPr sz="6614"/>
            </a:lvl3pPr>
            <a:lvl4pPr marL="7559985" indent="0">
              <a:buNone/>
              <a:defRPr sz="5512"/>
            </a:lvl4pPr>
            <a:lvl5pPr marL="10079980" indent="0">
              <a:buNone/>
              <a:defRPr sz="5512"/>
            </a:lvl5pPr>
            <a:lvl6pPr marL="12599975" indent="0">
              <a:buNone/>
              <a:defRPr sz="5512"/>
            </a:lvl6pPr>
            <a:lvl7pPr marL="15119970" indent="0">
              <a:buNone/>
              <a:defRPr sz="5512"/>
            </a:lvl7pPr>
            <a:lvl8pPr marL="17639965" indent="0">
              <a:buNone/>
              <a:defRPr sz="5512"/>
            </a:lvl8pPr>
            <a:lvl9pPr marL="20159960" indent="0">
              <a:buNone/>
              <a:defRPr sz="551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349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71561" y="3359997"/>
            <a:ext cx="16255296" cy="11759988"/>
          </a:xfrm>
        </p:spPr>
        <p:txBody>
          <a:bodyPr anchor="b"/>
          <a:lstStyle>
            <a:lvl1pPr>
              <a:defRPr sz="1763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1426543" y="7256671"/>
            <a:ext cx="25514975" cy="35816631"/>
          </a:xfrm>
        </p:spPr>
        <p:txBody>
          <a:bodyPr anchor="t"/>
          <a:lstStyle>
            <a:lvl1pPr marL="0" indent="0">
              <a:buNone/>
              <a:defRPr sz="17638"/>
            </a:lvl1pPr>
            <a:lvl2pPr marL="2519995" indent="0">
              <a:buNone/>
              <a:defRPr sz="15433"/>
            </a:lvl2pPr>
            <a:lvl3pPr marL="5039990" indent="0">
              <a:buNone/>
              <a:defRPr sz="13228"/>
            </a:lvl3pPr>
            <a:lvl4pPr marL="7559985" indent="0">
              <a:buNone/>
              <a:defRPr sz="11024"/>
            </a:lvl4pPr>
            <a:lvl5pPr marL="10079980" indent="0">
              <a:buNone/>
              <a:defRPr sz="11024"/>
            </a:lvl5pPr>
            <a:lvl6pPr marL="12599975" indent="0">
              <a:buNone/>
              <a:defRPr sz="11024"/>
            </a:lvl6pPr>
            <a:lvl7pPr marL="15119970" indent="0">
              <a:buNone/>
              <a:defRPr sz="11024"/>
            </a:lvl7pPr>
            <a:lvl8pPr marL="17639965" indent="0">
              <a:buNone/>
              <a:defRPr sz="11024"/>
            </a:lvl8pPr>
            <a:lvl9pPr marL="20159960" indent="0">
              <a:buNone/>
              <a:defRPr sz="11024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71561" y="15119985"/>
            <a:ext cx="16255296" cy="28011643"/>
          </a:xfrm>
        </p:spPr>
        <p:txBody>
          <a:bodyPr/>
          <a:lstStyle>
            <a:lvl1pPr marL="0" indent="0">
              <a:buNone/>
              <a:defRPr sz="8819"/>
            </a:lvl1pPr>
            <a:lvl2pPr marL="2519995" indent="0">
              <a:buNone/>
              <a:defRPr sz="7717"/>
            </a:lvl2pPr>
            <a:lvl3pPr marL="5039990" indent="0">
              <a:buNone/>
              <a:defRPr sz="6614"/>
            </a:lvl3pPr>
            <a:lvl4pPr marL="7559985" indent="0">
              <a:buNone/>
              <a:defRPr sz="5512"/>
            </a:lvl4pPr>
            <a:lvl5pPr marL="10079980" indent="0">
              <a:buNone/>
              <a:defRPr sz="5512"/>
            </a:lvl5pPr>
            <a:lvl6pPr marL="12599975" indent="0">
              <a:buNone/>
              <a:defRPr sz="5512"/>
            </a:lvl6pPr>
            <a:lvl7pPr marL="15119970" indent="0">
              <a:buNone/>
              <a:defRPr sz="5512"/>
            </a:lvl7pPr>
            <a:lvl8pPr marL="17639965" indent="0">
              <a:buNone/>
              <a:defRPr sz="5512"/>
            </a:lvl8pPr>
            <a:lvl9pPr marL="20159960" indent="0">
              <a:buNone/>
              <a:defRPr sz="551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257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64997" y="2683342"/>
            <a:ext cx="43469957" cy="97416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4997" y="13416653"/>
            <a:ext cx="43469957" cy="319783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64996" y="46713298"/>
            <a:ext cx="11339989" cy="2683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DDF2D-DEEA-4E55-98D5-A7CE50BFE704}" type="datetimeFigureOut">
              <a:rPr lang="en-US" smtClean="0"/>
              <a:t>11/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694984" y="46713298"/>
            <a:ext cx="17009983" cy="2683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5594965" y="46713298"/>
            <a:ext cx="11339989" cy="2683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1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FAC7B4-7010-4E64-B21A-0D83196F70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587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5039990" rtl="0" eaLnBrk="1" latinLnBrk="0" hangingPunct="1">
        <a:lnSpc>
          <a:spcPct val="90000"/>
        </a:lnSpc>
        <a:spcBef>
          <a:spcPct val="0"/>
        </a:spcBef>
        <a:buNone/>
        <a:defRPr sz="242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59997" indent="-1259997" algn="l" defTabSz="5039990" rtl="0" eaLnBrk="1" latinLnBrk="0" hangingPunct="1">
        <a:lnSpc>
          <a:spcPct val="90000"/>
        </a:lnSpc>
        <a:spcBef>
          <a:spcPts val="5512"/>
        </a:spcBef>
        <a:buFont typeface="Arial" panose="020B0604020202020204" pitchFamily="34" charset="0"/>
        <a:buChar char="•"/>
        <a:defRPr sz="15433" kern="1200">
          <a:solidFill>
            <a:schemeClr val="tx1"/>
          </a:solidFill>
          <a:latin typeface="+mn-lt"/>
          <a:ea typeface="+mn-ea"/>
          <a:cs typeface="+mn-cs"/>
        </a:defRPr>
      </a:lvl1pPr>
      <a:lvl2pPr marL="3779992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13228" kern="1200">
          <a:solidFill>
            <a:schemeClr val="tx1"/>
          </a:solidFill>
          <a:latin typeface="+mn-lt"/>
          <a:ea typeface="+mn-ea"/>
          <a:cs typeface="+mn-cs"/>
        </a:defRPr>
      </a:lvl2pPr>
      <a:lvl3pPr marL="6299987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3pPr>
      <a:lvl4pPr marL="8819982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4pPr>
      <a:lvl5pPr marL="11339977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5pPr>
      <a:lvl6pPr marL="13859972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6pPr>
      <a:lvl7pPr marL="16379967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7pPr>
      <a:lvl8pPr marL="18899962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8pPr>
      <a:lvl9pPr marL="21419957" indent="-1259997" algn="l" defTabSz="5039990" rtl="0" eaLnBrk="1" latinLnBrk="0" hangingPunct="1">
        <a:lnSpc>
          <a:spcPct val="90000"/>
        </a:lnSpc>
        <a:spcBef>
          <a:spcPts val="2756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1pPr>
      <a:lvl2pPr marL="2519995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2pPr>
      <a:lvl3pPr marL="503999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3pPr>
      <a:lvl4pPr marL="7559985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4pPr>
      <a:lvl5pPr marL="1007998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5pPr>
      <a:lvl6pPr marL="12599975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6pPr>
      <a:lvl7pPr marL="1511997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7pPr>
      <a:lvl8pPr marL="17639965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8pPr>
      <a:lvl9pPr marL="20159960" algn="l" defTabSz="5039990" rtl="0" eaLnBrk="1" latinLnBrk="0" hangingPunct="1">
        <a:defRPr sz="992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Arc 4">
            <a:extLst>
              <a:ext uri="{FF2B5EF4-FFF2-40B4-BE49-F238E27FC236}">
                <a16:creationId xmlns:a16="http://schemas.microsoft.com/office/drawing/2014/main" id="{8A6C8F61-3A82-42A3-93EB-1B89B04CCC68}"/>
              </a:ext>
            </a:extLst>
          </p:cNvPr>
          <p:cNvSpPr/>
          <p:nvPr/>
        </p:nvSpPr>
        <p:spPr>
          <a:xfrm>
            <a:off x="3860875" y="4687338"/>
            <a:ext cx="41645225" cy="24245167"/>
          </a:xfrm>
          <a:prstGeom prst="arc">
            <a:avLst>
              <a:gd name="adj1" fmla="val 12421080"/>
              <a:gd name="adj2" fmla="val 20175266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2000" dirty="0">
              <a:latin typeface="3ds Condensed Light" panose="02000503020000020004" pitchFamily="2" charset="0"/>
              <a:cs typeface="Calibri" panose="020F0502020204030204" pitchFamily="34" charset="0"/>
            </a:endParaRPr>
          </a:p>
        </p:txBody>
      </p:sp>
      <p:sp>
        <p:nvSpPr>
          <p:cNvPr id="6" name="Striped Right Arrow 2">
            <a:extLst>
              <a:ext uri="{FF2B5EF4-FFF2-40B4-BE49-F238E27FC236}">
                <a16:creationId xmlns:a16="http://schemas.microsoft.com/office/drawing/2014/main" id="{74820434-9183-4C5D-A56B-860450542818}"/>
              </a:ext>
            </a:extLst>
          </p:cNvPr>
          <p:cNvSpPr/>
          <p:nvPr/>
        </p:nvSpPr>
        <p:spPr>
          <a:xfrm rot="5400000">
            <a:off x="19629121" y="10962547"/>
            <a:ext cx="10169393" cy="2805118"/>
          </a:xfrm>
          <a:prstGeom prst="stripedRightArrow">
            <a:avLst>
              <a:gd name="adj1" fmla="val 34275"/>
              <a:gd name="adj2" fmla="val 12214"/>
            </a:avLst>
          </a:prstGeom>
          <a:gradFill flip="none" rotWithShape="1">
            <a:gsLst>
              <a:gs pos="0">
                <a:srgbClr val="0087B7">
                  <a:alpha val="97000"/>
                </a:srgbClr>
              </a:gs>
              <a:gs pos="97000">
                <a:srgbClr val="00CD7B"/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DD453D2-86CC-4417-AC5E-E3BF51DA05D4}"/>
              </a:ext>
            </a:extLst>
          </p:cNvPr>
          <p:cNvSpPr txBox="1"/>
          <p:nvPr/>
        </p:nvSpPr>
        <p:spPr>
          <a:xfrm>
            <a:off x="36650521" y="7280405"/>
            <a:ext cx="9008745" cy="2077164"/>
          </a:xfrm>
          <a:prstGeom prst="roundRect">
            <a:avLst/>
          </a:prstGeom>
          <a:gradFill flip="none" rotWithShape="1">
            <a:gsLst>
              <a:gs pos="100000">
                <a:schemeClr val="bg1">
                  <a:lumMod val="95000"/>
                </a:schemeClr>
              </a:gs>
              <a:gs pos="0">
                <a:schemeClr val="bg1">
                  <a:lumMod val="85000"/>
                </a:schemeClr>
              </a:gs>
            </a:gsLst>
            <a:lin ang="16200000" scaled="1"/>
            <a:tileRect/>
          </a:gradFill>
          <a:ln>
            <a:noFill/>
          </a:ln>
          <a:effectLst>
            <a:outerShdw blurRad="749300" sx="105000" sy="105000" algn="ctr" rotWithShape="0">
              <a:schemeClr val="tx1">
                <a:lumMod val="65000"/>
                <a:lumOff val="35000"/>
                <a:alpha val="40000"/>
              </a:schemeClr>
            </a:outerShdw>
          </a:effectLst>
        </p:spPr>
        <p:txBody>
          <a:bodyPr wrap="square" rtlCol="0">
            <a:spAutoFit/>
          </a:bodyPr>
          <a:lstStyle/>
          <a:p>
            <a:pPr algn="ctr"/>
            <a:r>
              <a:rPr lang="en-GB" sz="11600" dirty="0">
                <a:latin typeface="3ds Condensed Light" panose="02000503020000020004" pitchFamily="2" charset="0"/>
                <a:cs typeface="Calibri" panose="020F0502020204030204" pitchFamily="34" charset="0"/>
              </a:rPr>
              <a:t>GSE150910 </a:t>
            </a:r>
            <a:endParaRPr lang="en-GB" sz="800" dirty="0">
              <a:latin typeface="3ds Condensed Light" panose="02000503020000020004" pitchFamily="2" charset="0"/>
              <a:cs typeface="Calibri" panose="020F050202020403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0353149-110F-409C-8B03-2F19901D8F37}"/>
              </a:ext>
            </a:extLst>
          </p:cNvPr>
          <p:cNvSpPr txBox="1"/>
          <p:nvPr/>
        </p:nvSpPr>
        <p:spPr>
          <a:xfrm>
            <a:off x="3739428" y="7304190"/>
            <a:ext cx="9621310" cy="2077164"/>
          </a:xfrm>
          <a:prstGeom prst="roundRect">
            <a:avLst/>
          </a:prstGeom>
          <a:gradFill flip="none" rotWithShape="1">
            <a:gsLst>
              <a:gs pos="100000">
                <a:schemeClr val="bg1">
                  <a:lumMod val="95000"/>
                </a:schemeClr>
              </a:gs>
              <a:gs pos="0">
                <a:schemeClr val="bg1">
                  <a:lumMod val="85000"/>
                </a:schemeClr>
              </a:gs>
            </a:gsLst>
            <a:lin ang="16200000" scaled="1"/>
            <a:tileRect/>
          </a:gradFill>
          <a:ln>
            <a:noFill/>
          </a:ln>
          <a:effectLst>
            <a:outerShdw blurRad="749300" sx="105000" sy="105000" algn="ctr" rotWithShape="0">
              <a:schemeClr val="tx1">
                <a:lumMod val="65000"/>
                <a:lumOff val="35000"/>
                <a:alpha val="40000"/>
              </a:schemeClr>
            </a:outerShdw>
          </a:effectLst>
        </p:spPr>
        <p:txBody>
          <a:bodyPr wrap="square" rtlCol="0">
            <a:spAutoFit/>
          </a:bodyPr>
          <a:lstStyle/>
          <a:p>
            <a:pPr algn="ctr"/>
            <a:r>
              <a:rPr lang="en-GB" sz="11600" dirty="0">
                <a:latin typeface="3ds Condensed Light" panose="02000503020000020004" pitchFamily="2" charset="0"/>
                <a:cs typeface="Calibri" panose="020F0502020204030204" pitchFamily="34" charset="0"/>
              </a:rPr>
              <a:t>GSE213001</a:t>
            </a:r>
            <a:endParaRPr lang="en-GB" sz="800" dirty="0">
              <a:latin typeface="3ds Condensed Light" panose="02000503020000020004" pitchFamily="2" charset="0"/>
              <a:cs typeface="Calibri" panose="020F050202020403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87EA316-781D-49A4-9AC7-F0DEB6225D7E}"/>
              </a:ext>
            </a:extLst>
          </p:cNvPr>
          <p:cNvSpPr txBox="1"/>
          <p:nvPr/>
        </p:nvSpPr>
        <p:spPr>
          <a:xfrm>
            <a:off x="15916771" y="1828792"/>
            <a:ext cx="18007069" cy="4052174"/>
          </a:xfrm>
          <a:prstGeom prst="roundRect">
            <a:avLst/>
          </a:prstGeom>
          <a:gradFill flip="none" rotWithShape="1">
            <a:gsLst>
              <a:gs pos="100000">
                <a:schemeClr val="bg1">
                  <a:lumMod val="95000"/>
                </a:schemeClr>
              </a:gs>
              <a:gs pos="0">
                <a:schemeClr val="bg1">
                  <a:lumMod val="85000"/>
                </a:schemeClr>
              </a:gs>
            </a:gsLst>
            <a:lin ang="16200000" scaled="1"/>
            <a:tileRect/>
          </a:gradFill>
          <a:ln>
            <a:noFill/>
          </a:ln>
          <a:effectLst>
            <a:outerShdw blurRad="749300" sx="105000" sy="105000" algn="ctr" rotWithShape="0">
              <a:schemeClr val="tx1">
                <a:lumMod val="65000"/>
                <a:lumOff val="35000"/>
                <a:alpha val="40000"/>
              </a:schemeClr>
            </a:outerShdw>
          </a:effectLst>
        </p:spPr>
        <p:txBody>
          <a:bodyPr wrap="square" rtlCol="0">
            <a:spAutoFit/>
          </a:bodyPr>
          <a:lstStyle/>
          <a:p>
            <a:pPr algn="ctr"/>
            <a:r>
              <a:rPr lang="en-GB" sz="11600" dirty="0">
                <a:latin typeface="3ds Condensed Light" panose="02000503020000020004" pitchFamily="2" charset="0"/>
                <a:cs typeface="Calibri" panose="020F0502020204030204" pitchFamily="34" charset="0"/>
              </a:rPr>
              <a:t>Retrieval of NCBI-GEO Datasets for IPF Patients</a:t>
            </a:r>
            <a:endParaRPr lang="en-GB" sz="800" dirty="0">
              <a:latin typeface="3ds Condensed Light" panose="02000503020000020004" pitchFamily="2" charset="0"/>
              <a:cs typeface="Calibri" panose="020F050202020403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7A26DC2-9F41-47A0-B1E8-F239D11B9E52}"/>
              </a:ext>
            </a:extLst>
          </p:cNvPr>
          <p:cNvSpPr txBox="1"/>
          <p:nvPr/>
        </p:nvSpPr>
        <p:spPr>
          <a:xfrm>
            <a:off x="17804913" y="18122751"/>
            <a:ext cx="13507694" cy="2533501"/>
          </a:xfrm>
          <a:prstGeom prst="roundRect">
            <a:avLst>
              <a:gd name="adj" fmla="val 21783"/>
            </a:avLst>
          </a:prstGeom>
          <a:gradFill flip="none" rotWithShape="1">
            <a:gsLst>
              <a:gs pos="100000">
                <a:srgbClr val="00B7D0"/>
              </a:gs>
              <a:gs pos="0">
                <a:srgbClr val="0077C8"/>
              </a:gs>
            </a:gsLst>
            <a:lin ang="15600000" scaled="0"/>
            <a:tileRect/>
          </a:gradFill>
          <a:ln>
            <a:noFill/>
          </a:ln>
          <a:effectLst>
            <a:outerShdw blurRad="749300" sx="105000" sy="105000" algn="ctr" rotWithShape="0">
              <a:schemeClr val="tx1">
                <a:lumMod val="65000"/>
                <a:lumOff val="35000"/>
                <a:alpha val="40000"/>
              </a:schemeClr>
            </a:outerShdw>
          </a:effectLst>
        </p:spPr>
        <p:txBody>
          <a:bodyPr wrap="square" rtlCol="0">
            <a:spAutoFit/>
          </a:bodyPr>
          <a:lstStyle/>
          <a:p>
            <a:pPr lvl="0" algn="ctr"/>
            <a:r>
              <a:rPr lang="en-GB" sz="13900" dirty="0">
                <a:solidFill>
                  <a:schemeClr val="bg1">
                    <a:lumMod val="9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67 Common DEG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5CB6B59-3FF4-431F-B6B9-18B2E80B72B0}"/>
              </a:ext>
            </a:extLst>
          </p:cNvPr>
          <p:cNvSpPr txBox="1"/>
          <p:nvPr/>
        </p:nvSpPr>
        <p:spPr>
          <a:xfrm>
            <a:off x="26116377" y="9202269"/>
            <a:ext cx="23146923" cy="720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063120" indent="-1063120">
              <a:buFont typeface="Arial" panose="020B0604020202020204" pitchFamily="34" charset="0"/>
              <a:buChar char="•"/>
            </a:pPr>
            <a:r>
              <a:rPr lang="en-GB" sz="6600" dirty="0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Outlier removal (PCA)</a:t>
            </a:r>
          </a:p>
          <a:p>
            <a:pPr marL="1063120" indent="-1063120">
              <a:buFont typeface="Arial" panose="020B0604020202020204" pitchFamily="34" charset="0"/>
              <a:buChar char="•"/>
            </a:pPr>
            <a:r>
              <a:rPr lang="en-GB" sz="6600" dirty="0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Quantile normalization (</a:t>
            </a:r>
            <a:r>
              <a:rPr lang="en-GB" sz="66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GeneChip</a:t>
            </a:r>
            <a:r>
              <a:rPr lang="en-GB" sz="6600" dirty="0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)</a:t>
            </a:r>
          </a:p>
          <a:p>
            <a:pPr marL="1063120" indent="-1063120">
              <a:buFont typeface="Arial" panose="020B0604020202020204" pitchFamily="34" charset="0"/>
              <a:buChar char="•"/>
            </a:pPr>
            <a:r>
              <a:rPr lang="en-GB" sz="6600" dirty="0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Size-factor adjustment normalization (RNA-</a:t>
            </a:r>
            <a:r>
              <a:rPr lang="en-GB" sz="66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seq</a:t>
            </a:r>
            <a:r>
              <a:rPr lang="en-GB" sz="6600" dirty="0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)</a:t>
            </a:r>
          </a:p>
          <a:p>
            <a:pPr marL="1063120" indent="-1063120">
              <a:buFont typeface="Arial" panose="020B0604020202020204" pitchFamily="34" charset="0"/>
              <a:buChar char="•"/>
            </a:pPr>
            <a:r>
              <a:rPr lang="en-GB" sz="6600" dirty="0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Batch effect correction</a:t>
            </a:r>
          </a:p>
          <a:p>
            <a:pPr marL="1063120" indent="-1063120">
              <a:buFont typeface="Arial" panose="020B0604020202020204" pitchFamily="34" charset="0"/>
              <a:buChar char="•"/>
            </a:pPr>
            <a:r>
              <a:rPr lang="en-GB" sz="6600" dirty="0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Removal of low-expressed genes</a:t>
            </a:r>
          </a:p>
          <a:p>
            <a:pPr marL="1063120" indent="-1063120">
              <a:buFont typeface="Arial" panose="020B0604020202020204" pitchFamily="34" charset="0"/>
              <a:buChar char="•"/>
            </a:pPr>
            <a:r>
              <a:rPr lang="en-GB" sz="6600" dirty="0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Differential gene expression experiment</a:t>
            </a:r>
          </a:p>
          <a:p>
            <a:pPr marL="1063120" indent="-1063120">
              <a:buFont typeface="Arial" panose="020B0604020202020204" pitchFamily="34" charset="0"/>
              <a:buChar char="•"/>
            </a:pPr>
            <a:r>
              <a:rPr lang="en-GB" sz="6600" dirty="0">
                <a:solidFill>
                  <a:schemeClr val="tx1">
                    <a:lumMod val="75000"/>
                    <a:lumOff val="25000"/>
                  </a:schemeClr>
                </a:solidFill>
                <a:latin typeface="3ds Condensed Light" panose="02000503020000020004" pitchFamily="2" charset="0"/>
                <a:cs typeface="Calibri" panose="020F0502020204030204" pitchFamily="34" charset="0"/>
              </a:rPr>
              <a:t>Identification of DEGs (|log2FC|&gt;1, FDR&lt;0.01)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2476499" y="21526500"/>
            <a:ext cx="45720001" cy="24193499"/>
            <a:chOff x="7875431" y="17810371"/>
            <a:chExt cx="36907201" cy="13695722"/>
          </a:xfrm>
        </p:grpSpPr>
        <p:sp>
          <p:nvSpPr>
            <p:cNvPr id="26" name="Striped Right Arrow 25"/>
            <p:cNvSpPr/>
            <p:nvPr/>
          </p:nvSpPr>
          <p:spPr>
            <a:xfrm rot="5400000">
              <a:off x="19467556" y="22975711"/>
              <a:ext cx="12760719" cy="2430040"/>
            </a:xfrm>
            <a:prstGeom prst="stripedRightArrow">
              <a:avLst>
                <a:gd name="adj1" fmla="val 34275"/>
                <a:gd name="adj2" fmla="val 24059"/>
              </a:avLst>
            </a:prstGeom>
            <a:gradFill flip="none" rotWithShape="1">
              <a:gsLst>
                <a:gs pos="0">
                  <a:srgbClr val="D45B23"/>
                </a:gs>
                <a:gs pos="97000">
                  <a:srgbClr val="EFC10F"/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 sz="2400"/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7875431" y="18417763"/>
              <a:ext cx="36907201" cy="13088330"/>
              <a:chOff x="7875431" y="18417763"/>
              <a:chExt cx="36907201" cy="13088330"/>
            </a:xfrm>
          </p:grpSpPr>
          <p:sp>
            <p:nvSpPr>
              <p:cNvPr id="28" name="TextBox 54"/>
              <p:cNvSpPr txBox="1"/>
              <p:nvPr/>
            </p:nvSpPr>
            <p:spPr>
              <a:xfrm>
                <a:off x="7875431" y="18417763"/>
                <a:ext cx="36907201" cy="935004"/>
              </a:xfrm>
              <a:prstGeom prst="roundRect">
                <a:avLst>
                  <a:gd name="adj" fmla="val 21783"/>
                </a:avLst>
              </a:prstGeom>
              <a:gradFill flip="none" rotWithShape="1">
                <a:gsLst>
                  <a:gs pos="100000">
                    <a:schemeClr val="bg1">
                      <a:lumMod val="95000"/>
                    </a:schemeClr>
                  </a:gs>
                  <a:gs pos="0">
                    <a:schemeClr val="bg1">
                      <a:lumMod val="85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556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Analysis of </a:t>
                </a: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the correlation between the expression of DEGs and different diseases and comorbidities</a:t>
                </a:r>
              </a:p>
            </p:txBody>
          </p:sp>
          <p:sp>
            <p:nvSpPr>
              <p:cNvPr id="29" name="TextBox 72"/>
              <p:cNvSpPr txBox="1"/>
              <p:nvPr/>
            </p:nvSpPr>
            <p:spPr>
              <a:xfrm>
                <a:off x="7875431" y="20136146"/>
                <a:ext cx="36907201" cy="935004"/>
              </a:xfrm>
              <a:prstGeom prst="roundRect">
                <a:avLst>
                  <a:gd name="adj" fmla="val 21783"/>
                </a:avLst>
              </a:prstGeom>
              <a:gradFill flip="none" rotWithShape="1">
                <a:gsLst>
                  <a:gs pos="100000">
                    <a:schemeClr val="bg1">
                      <a:lumMod val="95000"/>
                    </a:schemeClr>
                  </a:gs>
                  <a:gs pos="0">
                    <a:schemeClr val="bg1">
                      <a:lumMod val="85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556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Analysis of </a:t>
                </a: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the correlation between the expression of DEGs and different diseases and comorbidities</a:t>
                </a:r>
              </a:p>
            </p:txBody>
          </p:sp>
          <p:sp>
            <p:nvSpPr>
              <p:cNvPr id="30" name="TextBox 73"/>
              <p:cNvSpPr txBox="1"/>
              <p:nvPr/>
            </p:nvSpPr>
            <p:spPr>
              <a:xfrm>
                <a:off x="7875431" y="21853507"/>
                <a:ext cx="36907201" cy="935004"/>
              </a:xfrm>
              <a:prstGeom prst="roundRect">
                <a:avLst>
                  <a:gd name="adj" fmla="val 21783"/>
                </a:avLst>
              </a:prstGeom>
              <a:gradFill flip="none" rotWithShape="1">
                <a:gsLst>
                  <a:gs pos="100000">
                    <a:schemeClr val="bg1">
                      <a:lumMod val="95000"/>
                    </a:schemeClr>
                  </a:gs>
                  <a:gs pos="0">
                    <a:schemeClr val="bg1">
                      <a:lumMod val="85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556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Analysis of the ontology terms and functional relevance of the DEGs</a:t>
                </a:r>
              </a:p>
            </p:txBody>
          </p:sp>
          <p:sp>
            <p:nvSpPr>
              <p:cNvPr id="31" name="TextBox 78"/>
              <p:cNvSpPr txBox="1"/>
              <p:nvPr/>
            </p:nvSpPr>
            <p:spPr>
              <a:xfrm>
                <a:off x="7875431" y="23570867"/>
                <a:ext cx="36907201" cy="935004"/>
              </a:xfrm>
              <a:prstGeom prst="roundRect">
                <a:avLst>
                  <a:gd name="adj" fmla="val 21783"/>
                </a:avLst>
              </a:prstGeom>
              <a:gradFill flip="none" rotWithShape="1">
                <a:gsLst>
                  <a:gs pos="100000">
                    <a:schemeClr val="bg1">
                      <a:lumMod val="95000"/>
                    </a:schemeClr>
                  </a:gs>
                  <a:gs pos="0">
                    <a:schemeClr val="bg1">
                      <a:lumMod val="85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556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The Co-expressed DEGs in IPF and Their Biological Roles in Disease Severity </a:t>
                </a:r>
              </a:p>
            </p:txBody>
          </p:sp>
          <p:sp>
            <p:nvSpPr>
              <p:cNvPr id="32" name="TextBox 79"/>
              <p:cNvSpPr txBox="1"/>
              <p:nvPr/>
            </p:nvSpPr>
            <p:spPr>
              <a:xfrm>
                <a:off x="7875431" y="25268313"/>
                <a:ext cx="36907201" cy="935004"/>
              </a:xfrm>
              <a:prstGeom prst="roundRect">
                <a:avLst>
                  <a:gd name="adj" fmla="val 21783"/>
                </a:avLst>
              </a:prstGeom>
              <a:gradFill flip="none" rotWithShape="1">
                <a:gsLst>
                  <a:gs pos="100000">
                    <a:schemeClr val="bg1">
                      <a:lumMod val="95000"/>
                    </a:schemeClr>
                  </a:gs>
                  <a:gs pos="0">
                    <a:schemeClr val="bg1">
                      <a:lumMod val="85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556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The Prediction Power of the DEGs in Differentiating IPF Phenotypes</a:t>
                </a:r>
              </a:p>
            </p:txBody>
          </p:sp>
          <p:sp>
            <p:nvSpPr>
              <p:cNvPr id="33" name="TextBox 84"/>
              <p:cNvSpPr txBox="1"/>
              <p:nvPr/>
            </p:nvSpPr>
            <p:spPr>
              <a:xfrm>
                <a:off x="7875431" y="27035905"/>
                <a:ext cx="36907201" cy="935004"/>
              </a:xfrm>
              <a:prstGeom prst="roundRect">
                <a:avLst>
                  <a:gd name="adj" fmla="val 21783"/>
                </a:avLst>
              </a:prstGeom>
              <a:gradFill flip="none" rotWithShape="1">
                <a:gsLst>
                  <a:gs pos="100000">
                    <a:schemeClr val="bg1">
                      <a:lumMod val="95000"/>
                    </a:schemeClr>
                  </a:gs>
                  <a:gs pos="0">
                    <a:schemeClr val="bg1">
                      <a:lumMod val="85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556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Construction of the protein-protein interaction network of DEGs and identification of hub proteins</a:t>
                </a:r>
              </a:p>
            </p:txBody>
          </p:sp>
          <p:sp>
            <p:nvSpPr>
              <p:cNvPr id="34" name="TextBox 85"/>
              <p:cNvSpPr txBox="1"/>
              <p:nvPr/>
            </p:nvSpPr>
            <p:spPr>
              <a:xfrm>
                <a:off x="7875431" y="28803497"/>
                <a:ext cx="36907201" cy="935004"/>
              </a:xfrm>
              <a:prstGeom prst="roundRect">
                <a:avLst>
                  <a:gd name="adj" fmla="val 21783"/>
                </a:avLst>
              </a:prstGeom>
              <a:gradFill flip="none" rotWithShape="1">
                <a:gsLst>
                  <a:gs pos="100000">
                    <a:schemeClr val="bg1">
                      <a:lumMod val="95000"/>
                    </a:schemeClr>
                  </a:gs>
                  <a:gs pos="0">
                    <a:schemeClr val="bg1">
                      <a:lumMod val="85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556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Identification of transcriptional and post-transcriptional regulatory signatures </a:t>
                </a: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and </a:t>
                </a: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drug targets of the DEGs</a:t>
                </a:r>
              </a:p>
            </p:txBody>
          </p:sp>
          <p:sp>
            <p:nvSpPr>
              <p:cNvPr id="35" name="TextBox 86"/>
              <p:cNvSpPr txBox="1"/>
              <p:nvPr/>
            </p:nvSpPr>
            <p:spPr>
              <a:xfrm>
                <a:off x="7875431" y="30571089"/>
                <a:ext cx="36907201" cy="935004"/>
              </a:xfrm>
              <a:prstGeom prst="roundRect">
                <a:avLst>
                  <a:gd name="adj" fmla="val 21783"/>
                </a:avLst>
              </a:prstGeom>
              <a:gradFill flip="none" rotWithShape="1">
                <a:gsLst>
                  <a:gs pos="100000">
                    <a:schemeClr val="bg1">
                      <a:lumMod val="95000"/>
                    </a:schemeClr>
                  </a:gs>
                  <a:gs pos="0">
                    <a:schemeClr val="bg1">
                      <a:lumMod val="85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  <a:effectLst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35560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GB" sz="88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3ds Condensed Light" panose="02000503020000020004" pitchFamily="2" charset="0"/>
                  </a:rPr>
                  <a:t>The Expression Patterns of the DEGs in Independent Dataset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47932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146</Words>
  <Application>Microsoft Office PowerPoint</Application>
  <PresentationFormat>Custom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3ds Condensed Light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Tayab Moin</cp:lastModifiedBy>
  <cp:revision>3</cp:revision>
  <dcterms:created xsi:type="dcterms:W3CDTF">2024-10-30T18:33:31Z</dcterms:created>
  <dcterms:modified xsi:type="dcterms:W3CDTF">2024-11-09T01:33:19Z</dcterms:modified>
</cp:coreProperties>
</file>